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0" d="100"/>
          <a:sy n="90" d="100"/>
        </p:scale>
        <p:origin x="-120" y="-25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jflorenc\Desktop\Histology%20Data%20for%20Graphing%20-%20athero%20article%202017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jflorenc\Desktop\Histology%20Data%20for%20Graphing%20-%20athero%20article%202017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400">
                <a:latin typeface="Arial" panose="020B0604020202020204" pitchFamily="34" charset="0"/>
                <a:cs typeface="Arial" panose="020B0604020202020204" pitchFamily="34" charset="0"/>
              </a:defRPr>
            </a:pP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Lesser</a:t>
            </a:r>
            <a:r>
              <a:rPr lang="en-US" sz="1400" baseline="0" dirty="0" smtClean="0">
                <a:latin typeface="Arial" panose="020B0604020202020204" pitchFamily="34" charset="0"/>
                <a:cs typeface="Arial" panose="020B0604020202020204" pitchFamily="34" charset="0"/>
              </a:rPr>
              <a:t> Curvature Lesion Area (ORO) </a:t>
            </a:r>
          </a:p>
        </c:rich>
      </c:tx>
      <c:layout>
        <c:manualLayout>
          <c:xMode val="edge"/>
          <c:yMode val="edge"/>
          <c:x val="0.16634991935247295"/>
          <c:y val="0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0.18339948297334693"/>
          <c:y val="0.11158573928258968"/>
          <c:w val="0.79978442272347416"/>
          <c:h val="0.77243438320209978"/>
        </c:manualLayout>
      </c:layout>
      <c:barChart>
        <c:barDir val="col"/>
        <c:grouping val="clustered"/>
        <c:varyColors val="0"/>
        <c:ser>
          <c:idx val="7"/>
          <c:order val="7"/>
          <c:spPr>
            <a:solidFill>
              <a:schemeClr val="bg1">
                <a:lumMod val="50000"/>
              </a:schemeClr>
            </a:solidFill>
            <a:ln w="15875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13wk ORO Plq Area'!$B$30:$E$30</c:f>
                <c:numCache>
                  <c:formatCode>General</c:formatCode>
                  <c:ptCount val="4"/>
                  <c:pt idx="0">
                    <c:v>5099.3788765629197</c:v>
                  </c:pt>
                  <c:pt idx="1">
                    <c:v>4734.5416191232143</c:v>
                  </c:pt>
                  <c:pt idx="2">
                    <c:v>1807.9455416425412</c:v>
                  </c:pt>
                  <c:pt idx="3">
                    <c:v>576.83278219178158</c:v>
                  </c:pt>
                </c:numCache>
              </c:numRef>
            </c:plus>
            <c:minus>
              <c:numRef>
                <c:f>'13wk ORO Plq Area'!$B$30:$E$30</c:f>
                <c:numCache>
                  <c:formatCode>General</c:formatCode>
                  <c:ptCount val="4"/>
                  <c:pt idx="0">
                    <c:v>5099.3788765629197</c:v>
                  </c:pt>
                  <c:pt idx="1">
                    <c:v>4734.5416191232143</c:v>
                  </c:pt>
                  <c:pt idx="2">
                    <c:v>1807.9455416425412</c:v>
                  </c:pt>
                  <c:pt idx="3">
                    <c:v>576.83278219178158</c:v>
                  </c:pt>
                </c:numCache>
              </c:numRef>
            </c:minus>
          </c:errBars>
          <c:cat>
            <c:numRef>
              <c:f>'13wk ORO Plq Area'!$B$19:$E$19</c:f>
              <c:numCache>
                <c:formatCode>General</c:formatCode>
                <c:ptCount val="4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</c:numCache>
            </c:numRef>
          </c:cat>
          <c:val>
            <c:numRef>
              <c:f>'13wk ORO Plq Area'!$B$28:$E$28</c:f>
              <c:numCache>
                <c:formatCode>General</c:formatCode>
                <c:ptCount val="4"/>
                <c:pt idx="0">
                  <c:v>31062.191666666666</c:v>
                </c:pt>
                <c:pt idx="1">
                  <c:v>8907.7555555555555</c:v>
                </c:pt>
                <c:pt idx="2">
                  <c:v>7945.8208333333332</c:v>
                </c:pt>
                <c:pt idx="3">
                  <c:v>1646.316666666666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6607872"/>
        <c:axId val="36609408"/>
      </c:barChart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('13wk ORO Plq Area'!$B$19,'13wk ORO Plq Area'!$C$19,'13wk ORO Plq Area'!$D$18,'13wk ORO Plq Area'!$G$18)</c:f>
              <c:numCache>
                <c:formatCode>General</c:formatCode>
                <c:ptCount val="4"/>
                <c:pt idx="0">
                  <c:v>1</c:v>
                </c:pt>
                <c:pt idx="1">
                  <c:v>2</c:v>
                </c:pt>
                <c:pt idx="2">
                  <c:v>2.96</c:v>
                </c:pt>
                <c:pt idx="3">
                  <c:v>3.9649999999999999</c:v>
                </c:pt>
              </c:numCache>
            </c:numRef>
          </c:xVal>
          <c:yVal>
            <c:numRef>
              <c:f>'13wk ORO Plq Area'!$B$21:$E$21</c:f>
              <c:numCache>
                <c:formatCode>General</c:formatCode>
                <c:ptCount val="4"/>
                <c:pt idx="0">
                  <c:v>42332</c:v>
                </c:pt>
                <c:pt idx="1">
                  <c:v>1952.6666666666667</c:v>
                </c:pt>
                <c:pt idx="2">
                  <c:v>8611.4</c:v>
                </c:pt>
                <c:pt idx="3">
                  <c:v>816.25</c:v>
                </c:pt>
              </c:numCache>
            </c:numRef>
          </c:yVal>
          <c:smooth val="0"/>
        </c:ser>
        <c:ser>
          <c:idx val="1"/>
          <c:order val="1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('13wk ORO Plq Area'!$B$19,'13wk ORO Plq Area'!$B$18,'13wk ORO Plq Area'!$D$19,'13wk ORO Plq Area'!$E$19)</c:f>
              <c:numCache>
                <c:formatCode>General</c:formatCode>
                <c:ptCount val="4"/>
                <c:pt idx="0">
                  <c:v>1</c:v>
                </c:pt>
                <c:pt idx="1">
                  <c:v>1.96</c:v>
                </c:pt>
                <c:pt idx="2">
                  <c:v>3</c:v>
                </c:pt>
                <c:pt idx="3">
                  <c:v>4</c:v>
                </c:pt>
              </c:numCache>
            </c:numRef>
          </c:xVal>
          <c:yVal>
            <c:numRef>
              <c:f>'13wk ORO Plq Area'!$B$22:$E$22</c:f>
              <c:numCache>
                <c:formatCode>General</c:formatCode>
                <c:ptCount val="4"/>
                <c:pt idx="0">
                  <c:v>21660.75</c:v>
                </c:pt>
                <c:pt idx="1">
                  <c:v>4246.1111111111113</c:v>
                </c:pt>
                <c:pt idx="2">
                  <c:v>11601.75</c:v>
                </c:pt>
                <c:pt idx="3">
                  <c:v>3874.5</c:v>
                </c:pt>
              </c:numCache>
            </c:numRef>
          </c:yVal>
          <c:smooth val="0"/>
        </c:ser>
        <c:ser>
          <c:idx val="2"/>
          <c:order val="2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('13wk ORO Plq Area'!$B$19,'13wk ORO Plq Area'!$C$19,'13wk ORO Plq Area'!$D$19,'13wk ORO Plq Area'!$F$18)</c:f>
              <c:numCache>
                <c:formatCode>General</c:formatCode>
                <c:ptCount val="4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3.9049999999999998</c:v>
                </c:pt>
              </c:numCache>
            </c:numRef>
          </c:xVal>
          <c:yVal>
            <c:numRef>
              <c:f>'13wk ORO Plq Area'!$B$23:$E$23</c:f>
              <c:numCache>
                <c:formatCode>General</c:formatCode>
                <c:ptCount val="4"/>
                <c:pt idx="0">
                  <c:v>19940.5</c:v>
                </c:pt>
                <c:pt idx="1">
                  <c:v>8898</c:v>
                </c:pt>
                <c:pt idx="2">
                  <c:v>2949.8</c:v>
                </c:pt>
                <c:pt idx="3">
                  <c:v>1534.5</c:v>
                </c:pt>
              </c:numCache>
            </c:numRef>
          </c:yVal>
          <c:smooth val="0"/>
        </c:ser>
        <c:ser>
          <c:idx val="3"/>
          <c:order val="3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('13wk ORO Plq Area'!$B$19,'13wk ORO Plq Area'!$C$19,'13wk ORO Plq Area'!$E$18,'13wk ORO Plq Area'!$H$18)</c:f>
              <c:numCache>
                <c:formatCode>General</c:formatCode>
                <c:ptCount val="4"/>
                <c:pt idx="0">
                  <c:v>1</c:v>
                </c:pt>
                <c:pt idx="1">
                  <c:v>2</c:v>
                </c:pt>
                <c:pt idx="2">
                  <c:v>3.04</c:v>
                </c:pt>
                <c:pt idx="3">
                  <c:v>4.0350000000000001</c:v>
                </c:pt>
              </c:numCache>
            </c:numRef>
          </c:xVal>
          <c:yVal>
            <c:numRef>
              <c:f>'13wk ORO Plq Area'!$B$24:$E$24</c:f>
              <c:numCache>
                <c:formatCode>General</c:formatCode>
                <c:ptCount val="4"/>
                <c:pt idx="0">
                  <c:v>23573.4</c:v>
                </c:pt>
                <c:pt idx="1">
                  <c:v>25232</c:v>
                </c:pt>
                <c:pt idx="2">
                  <c:v>8620.3333333333339</c:v>
                </c:pt>
                <c:pt idx="3">
                  <c:v>719.33333333333337</c:v>
                </c:pt>
              </c:numCache>
            </c:numRef>
          </c:yVal>
          <c:smooth val="0"/>
        </c:ser>
        <c:ser>
          <c:idx val="4"/>
          <c:order val="4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('13wk ORO Plq Area'!$B$19,'13wk ORO Plq Area'!$C$18,'13wk ORO Plq Area'!$D$19,'13wk ORO Plq Area'!$I$18)</c:f>
              <c:numCache>
                <c:formatCode>General</c:formatCode>
                <c:ptCount val="4"/>
                <c:pt idx="0">
                  <c:v>1</c:v>
                </c:pt>
                <c:pt idx="1">
                  <c:v>2.04</c:v>
                </c:pt>
                <c:pt idx="2">
                  <c:v>3</c:v>
                </c:pt>
                <c:pt idx="3">
                  <c:v>4.0999999999999996</c:v>
                </c:pt>
              </c:numCache>
            </c:numRef>
          </c:xVal>
          <c:yVal>
            <c:numRef>
              <c:f>'13wk ORO Plq Area'!$B$25:$E$25</c:f>
              <c:numCache>
                <c:formatCode>General</c:formatCode>
                <c:ptCount val="4"/>
                <c:pt idx="0">
                  <c:v>50496.5</c:v>
                </c:pt>
                <c:pt idx="1">
                  <c:v>4210</c:v>
                </c:pt>
                <c:pt idx="3">
                  <c:v>1287</c:v>
                </c:pt>
              </c:numCache>
            </c:numRef>
          </c:yVal>
          <c:smooth val="0"/>
        </c:ser>
        <c:ser>
          <c:idx val="5"/>
          <c:order val="5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'13wk ORO Plq Area'!$B$19:$E$19</c:f>
              <c:numCache>
                <c:formatCode>General</c:formatCode>
                <c:ptCount val="4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</c:numCache>
            </c:numRef>
          </c:xVal>
          <c:yVal>
            <c:numRef>
              <c:f>'13wk ORO Plq Area'!$B$26:$E$26</c:f>
              <c:numCache>
                <c:formatCode>General</c:formatCode>
                <c:ptCount val="4"/>
                <c:pt idx="0">
                  <c:v>28370</c:v>
                </c:pt>
              </c:numCache>
            </c:numRef>
          </c:yVal>
          <c:smooth val="0"/>
        </c:ser>
        <c:ser>
          <c:idx val="6"/>
          <c:order val="6"/>
          <c:spPr>
            <a:ln w="28575">
              <a:noFill/>
            </a:ln>
          </c:spPr>
          <c:xVal>
            <c:numRef>
              <c:f>'13wk ORO Plq Area'!$B$19:$E$19</c:f>
              <c:numCache>
                <c:formatCode>General</c:formatCode>
                <c:ptCount val="4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</c:numCache>
            </c:numRef>
          </c:xVal>
          <c:yVal>
            <c:numRef>
              <c:f>'13wk ORO Plq Area'!$B$27:$E$27</c:f>
              <c:numCache>
                <c:formatCode>General</c:formatCode>
                <c:ptCount val="4"/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6607872"/>
        <c:axId val="36609408"/>
      </c:scatterChart>
      <c:catAx>
        <c:axId val="3660787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crossAx val="36609408"/>
        <c:crosses val="autoZero"/>
        <c:auto val="1"/>
        <c:lblAlgn val="ctr"/>
        <c:lblOffset val="100"/>
        <c:noMultiLvlLbl val="0"/>
      </c:catAx>
      <c:valAx>
        <c:axId val="36609408"/>
        <c:scaling>
          <c:orientation val="minMax"/>
          <c:max val="6000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baseline="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esion  Area (</a:t>
                </a:r>
                <a:r>
                  <a:rPr lang="el-GR" baseline="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μ</a:t>
                </a:r>
                <a:r>
                  <a:rPr lang="en-US" baseline="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²)</a:t>
                </a:r>
                <a:endParaRPr 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0"/>
              <c:y val="0.29804571303587052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1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36607872"/>
        <c:crosses val="autoZero"/>
        <c:crossBetween val="between"/>
        <c:majorUnit val="20000"/>
      </c:valAx>
      <c:spPr>
        <a:solidFill>
          <a:schemeClr val="bg1">
            <a:lumMod val="95000"/>
          </a:schemeClr>
        </a:solidFill>
        <a:ln>
          <a:noFill/>
        </a:ln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400">
                <a:latin typeface="Arial" panose="020B0604020202020204" pitchFamily="34" charset="0"/>
                <a:cs typeface="Arial" panose="020B0604020202020204" pitchFamily="34" charset="0"/>
              </a:defRPr>
            </a:pP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Innominate Artery Lesion Area (ORO) </a:t>
            </a:r>
          </a:p>
        </c:rich>
      </c:tx>
      <c:layout>
        <c:manualLayout>
          <c:xMode val="edge"/>
          <c:yMode val="edge"/>
          <c:x val="0.14885802469135803"/>
          <c:y val="9.2592592592592587E-3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0.1838424710800039"/>
          <c:y val="0.11158573928258968"/>
          <c:w val="0.7996505297948866"/>
          <c:h val="0.77243438320209978"/>
        </c:manualLayout>
      </c:layout>
      <c:barChart>
        <c:barDir val="col"/>
        <c:grouping val="clustered"/>
        <c:varyColors val="0"/>
        <c:ser>
          <c:idx val="7"/>
          <c:order val="7"/>
          <c:spPr>
            <a:solidFill>
              <a:schemeClr val="bg1">
                <a:lumMod val="50000"/>
              </a:schemeClr>
            </a:solidFill>
            <a:ln w="15875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13wk ORO Plq Area'!$B$14:$E$14</c:f>
                <c:numCache>
                  <c:formatCode>General</c:formatCode>
                  <c:ptCount val="4"/>
                  <c:pt idx="0">
                    <c:v>5761.1061225748563</c:v>
                  </c:pt>
                  <c:pt idx="1">
                    <c:v>3115.7496350017609</c:v>
                  </c:pt>
                  <c:pt idx="2">
                    <c:v>2720.0343176450301</c:v>
                  </c:pt>
                  <c:pt idx="3">
                    <c:v>1677.7658061475013</c:v>
                  </c:pt>
                </c:numCache>
              </c:numRef>
            </c:plus>
            <c:minus>
              <c:numRef>
                <c:f>'13wk ORO Plq Area'!$B$14:$E$14</c:f>
                <c:numCache>
                  <c:formatCode>General</c:formatCode>
                  <c:ptCount val="4"/>
                  <c:pt idx="0">
                    <c:v>5761.1061225748563</c:v>
                  </c:pt>
                  <c:pt idx="1">
                    <c:v>3115.7496350017609</c:v>
                  </c:pt>
                  <c:pt idx="2">
                    <c:v>2720.0343176450301</c:v>
                  </c:pt>
                  <c:pt idx="3">
                    <c:v>1677.7658061475013</c:v>
                  </c:pt>
                </c:numCache>
              </c:numRef>
            </c:minus>
          </c:errBars>
          <c:cat>
            <c:numRef>
              <c:f>'13wk ORO Plq Area'!$B$3:$E$3</c:f>
              <c:numCache>
                <c:formatCode>General</c:formatCode>
                <c:ptCount val="4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</c:numCache>
            </c:numRef>
          </c:cat>
          <c:val>
            <c:numRef>
              <c:f>'13wk ORO Plq Area'!$B$12:$E$12</c:f>
              <c:numCache>
                <c:formatCode>General</c:formatCode>
                <c:ptCount val="4"/>
                <c:pt idx="0">
                  <c:v>31373.941666666666</c:v>
                </c:pt>
                <c:pt idx="1">
                  <c:v>11997.635416666666</c:v>
                </c:pt>
                <c:pt idx="2">
                  <c:v>23104.25</c:v>
                </c:pt>
                <c:pt idx="3">
                  <c:v>8209.816666666667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7155584"/>
        <c:axId val="37157504"/>
      </c:barChart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('13wk ORO Plq Area'!$B$3,'13wk ORO Plq Area'!$C$3,'13wk ORO Plq Area'!$D$3,'13wk ORO Plq Area'!$E$2)</c:f>
              <c:numCache>
                <c:formatCode>General</c:formatCode>
                <c:ptCount val="4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3.9649999999999999</c:v>
                </c:pt>
              </c:numCache>
            </c:numRef>
          </c:xVal>
          <c:yVal>
            <c:numRef>
              <c:f>'13wk ORO Plq Area'!$B$5:$E$5</c:f>
              <c:numCache>
                <c:formatCode>General</c:formatCode>
                <c:ptCount val="4"/>
                <c:pt idx="0">
                  <c:v>12837.6</c:v>
                </c:pt>
                <c:pt idx="1">
                  <c:v>4320.333333333333</c:v>
                </c:pt>
                <c:pt idx="2">
                  <c:v>21135.599999999999</c:v>
                </c:pt>
                <c:pt idx="3">
                  <c:v>4094</c:v>
                </c:pt>
              </c:numCache>
            </c:numRef>
          </c:yVal>
          <c:smooth val="0"/>
        </c:ser>
        <c:ser>
          <c:idx val="1"/>
          <c:order val="1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('13wk ORO Plq Area'!$B$3,'13wk ORO Plq Area'!$C$3,'13wk ORO Plq Area'!$D$3,'13wk ORO Plq Area'!$E$2)</c:f>
              <c:numCache>
                <c:formatCode>General</c:formatCode>
                <c:ptCount val="4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3.9649999999999999</c:v>
                </c:pt>
              </c:numCache>
            </c:numRef>
          </c:xVal>
          <c:yVal>
            <c:numRef>
              <c:f>'13wk ORO Plq Area'!$B$6:$E$6</c:f>
              <c:numCache>
                <c:formatCode>General</c:formatCode>
                <c:ptCount val="4"/>
                <c:pt idx="0">
                  <c:v>28903</c:v>
                </c:pt>
                <c:pt idx="1">
                  <c:v>18885</c:v>
                </c:pt>
                <c:pt idx="2">
                  <c:v>24626</c:v>
                </c:pt>
                <c:pt idx="3">
                  <c:v>9076.5</c:v>
                </c:pt>
              </c:numCache>
            </c:numRef>
          </c:yVal>
          <c:smooth val="0"/>
        </c:ser>
        <c:ser>
          <c:idx val="2"/>
          <c:order val="2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('13wk ORO Plq Area'!$B$3,'13wk ORO Plq Area'!$C$3,'13wk ORO Plq Area'!$D$3,'13wk ORO Plq Area'!$F$2)</c:f>
              <c:numCache>
                <c:formatCode>General</c:formatCode>
                <c:ptCount val="4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.0350000000000001</c:v>
                </c:pt>
              </c:numCache>
            </c:numRef>
          </c:xVal>
          <c:yVal>
            <c:numRef>
              <c:f>'13wk ORO Plq Area'!$B$7:$E$7</c:f>
              <c:numCache>
                <c:formatCode>General</c:formatCode>
                <c:ptCount val="4"/>
                <c:pt idx="0">
                  <c:v>18927.75</c:v>
                </c:pt>
                <c:pt idx="1">
                  <c:v>10178.333333333334</c:v>
                </c:pt>
                <c:pt idx="2">
                  <c:v>29750</c:v>
                </c:pt>
                <c:pt idx="3">
                  <c:v>8762.5</c:v>
                </c:pt>
              </c:numCache>
            </c:numRef>
          </c:yVal>
          <c:smooth val="0"/>
        </c:ser>
        <c:ser>
          <c:idx val="3"/>
          <c:order val="3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'13wk ORO Plq Area'!$B$3:$E$3</c:f>
              <c:numCache>
                <c:formatCode>General</c:formatCode>
                <c:ptCount val="4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</c:numCache>
            </c:numRef>
          </c:xVal>
          <c:yVal>
            <c:numRef>
              <c:f>'13wk ORO Plq Area'!$B$8:$E$8</c:f>
              <c:numCache>
                <c:formatCode>General</c:formatCode>
                <c:ptCount val="4"/>
                <c:pt idx="0">
                  <c:v>39613.800000000003</c:v>
                </c:pt>
                <c:pt idx="1">
                  <c:v>14606.875</c:v>
                </c:pt>
                <c:pt idx="2">
                  <c:v>16905.400000000001</c:v>
                </c:pt>
                <c:pt idx="3">
                  <c:v>13721.333333333334</c:v>
                </c:pt>
              </c:numCache>
            </c:numRef>
          </c:yVal>
          <c:smooth val="0"/>
        </c:ser>
        <c:ser>
          <c:idx val="4"/>
          <c:order val="4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('13wk ORO Plq Area'!$B$3,'13wk ORO Plq Area'!$C$3,'13wk ORO Plq Area'!$D$3,'13wk ORO Plq Area'!$F$2)</c:f>
              <c:numCache>
                <c:formatCode>General</c:formatCode>
                <c:ptCount val="4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.0350000000000001</c:v>
                </c:pt>
              </c:numCache>
            </c:numRef>
          </c:xVal>
          <c:yVal>
            <c:numRef>
              <c:f>'13wk ORO Plq Area'!$B$9:$E$9</c:f>
              <c:numCache>
                <c:formatCode>General</c:formatCode>
                <c:ptCount val="4"/>
                <c:pt idx="0">
                  <c:v>36723.25</c:v>
                </c:pt>
                <c:pt idx="3">
                  <c:v>5394.75</c:v>
                </c:pt>
              </c:numCache>
            </c:numRef>
          </c:yVal>
          <c:smooth val="0"/>
        </c:ser>
        <c:ser>
          <c:idx val="5"/>
          <c:order val="5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'13wk ORO Plq Area'!$B$3:$E$3</c:f>
              <c:numCache>
                <c:formatCode>General</c:formatCode>
                <c:ptCount val="4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</c:numCache>
            </c:numRef>
          </c:xVal>
          <c:yVal>
            <c:numRef>
              <c:f>'13wk ORO Plq Area'!$B$10:$E$10</c:f>
              <c:numCache>
                <c:formatCode>General</c:formatCode>
                <c:ptCount val="4"/>
                <c:pt idx="0">
                  <c:v>51238.25</c:v>
                </c:pt>
              </c:numCache>
            </c:numRef>
          </c:yVal>
          <c:smooth val="0"/>
        </c:ser>
        <c:ser>
          <c:idx val="6"/>
          <c:order val="6"/>
          <c:spPr>
            <a:ln w="28575">
              <a:noFill/>
            </a:ln>
          </c:spPr>
          <c:xVal>
            <c:numRef>
              <c:f>'13wk ORO Plq Area'!$B$3:$E$3</c:f>
              <c:numCache>
                <c:formatCode>General</c:formatCode>
                <c:ptCount val="4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</c:numCache>
            </c:numRef>
          </c:xVal>
          <c:yVal>
            <c:numRef>
              <c:f>'13wk ORO Plq Area'!$B$11:$E$11</c:f>
              <c:numCache>
                <c:formatCode>General</c:formatCode>
                <c:ptCount val="4"/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7155584"/>
        <c:axId val="37157504"/>
      </c:scatterChart>
      <c:catAx>
        <c:axId val="3715558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crossAx val="37157504"/>
        <c:crosses val="autoZero"/>
        <c:auto val="1"/>
        <c:lblAlgn val="ctr"/>
        <c:lblOffset val="100"/>
        <c:noMultiLvlLbl val="0"/>
      </c:catAx>
      <c:valAx>
        <c:axId val="3715750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aseline="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baseline="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esion Area (</a:t>
                </a:r>
                <a:r>
                  <a:rPr lang="el-GR" baseline="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μ</a:t>
                </a:r>
                <a:r>
                  <a:rPr lang="en-US" baseline="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²)</a:t>
                </a:r>
                <a:endParaRPr lang="en-US" baseline="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0"/>
              <c:y val="0.29573089822105569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1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37155584"/>
        <c:crosses val="autoZero"/>
        <c:crossBetween val="between"/>
        <c:majorUnit val="20000"/>
      </c:valAx>
      <c:spPr>
        <a:solidFill>
          <a:schemeClr val="bg1">
            <a:lumMod val="95000"/>
          </a:schemeClr>
        </a:solidFill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400">
                <a:latin typeface="Arial" panose="020B0604020202020204" pitchFamily="34" charset="0"/>
                <a:cs typeface="Arial" panose="020B0604020202020204" pitchFamily="34" charset="0"/>
              </a:defRPr>
            </a:pP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Lesser Curvature</a:t>
            </a:r>
          </a:p>
          <a:p>
            <a:pPr>
              <a:defRPr sz="1400">
                <a:latin typeface="Arial" panose="020B0604020202020204" pitchFamily="34" charset="0"/>
                <a:cs typeface="Arial" panose="020B0604020202020204" pitchFamily="34" charset="0"/>
              </a:defRPr>
            </a:pP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ollagen Content (PS Red)</a:t>
            </a:r>
          </a:p>
        </c:rich>
      </c:tx>
      <c:layout>
        <c:manualLayout>
          <c:xMode val="edge"/>
          <c:yMode val="edge"/>
          <c:x val="0.22385256984259275"/>
          <c:y val="0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0.10821862714957341"/>
          <c:y val="0.16666666666666666"/>
          <c:w val="0.86122588716032256"/>
          <c:h val="0.78240740740740744"/>
        </c:manualLayout>
      </c:layout>
      <c:barChart>
        <c:barDir val="col"/>
        <c:grouping val="clustered"/>
        <c:varyColors val="0"/>
        <c:ser>
          <c:idx val="5"/>
          <c:order val="5"/>
          <c:spPr>
            <a:solidFill>
              <a:schemeClr val="bg1">
                <a:lumMod val="50000"/>
              </a:schemeClr>
            </a:solidFill>
            <a:ln w="15875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13wk PS Red data'!$B$12:$E$12</c:f>
                <c:numCache>
                  <c:formatCode>General</c:formatCode>
                  <c:ptCount val="4"/>
                  <c:pt idx="0">
                    <c:v>3.0898851246611172</c:v>
                  </c:pt>
                  <c:pt idx="1">
                    <c:v>2.8305083357796601</c:v>
                  </c:pt>
                  <c:pt idx="2">
                    <c:v>2.3230159693003145</c:v>
                  </c:pt>
                  <c:pt idx="3">
                    <c:v>1.0239589492453904</c:v>
                  </c:pt>
                </c:numCache>
              </c:numRef>
            </c:plus>
            <c:minus>
              <c:numRef>
                <c:f>'13wk PS Red data'!$B$12:$E$12</c:f>
                <c:numCache>
                  <c:formatCode>General</c:formatCode>
                  <c:ptCount val="4"/>
                  <c:pt idx="0">
                    <c:v>3.0898851246611172</c:v>
                  </c:pt>
                  <c:pt idx="1">
                    <c:v>2.8305083357796601</c:v>
                  </c:pt>
                  <c:pt idx="2">
                    <c:v>2.3230159693003145</c:v>
                  </c:pt>
                  <c:pt idx="3">
                    <c:v>1.0239589492453904</c:v>
                  </c:pt>
                </c:numCache>
              </c:numRef>
            </c:minus>
          </c:errBars>
          <c:cat>
            <c:numRef>
              <c:f>'13wk PS Red data'!$B$3:$E$3</c:f>
              <c:numCache>
                <c:formatCode>General</c:formatCode>
                <c:ptCount val="4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</c:numCache>
            </c:numRef>
          </c:cat>
          <c:val>
            <c:numRef>
              <c:f>'13wk PS Red data'!$B$10:$E$10</c:f>
              <c:numCache>
                <c:formatCode>0.00</c:formatCode>
                <c:ptCount val="4"/>
                <c:pt idx="0">
                  <c:v>21.241069325790271</c:v>
                </c:pt>
                <c:pt idx="1">
                  <c:v>25.382104232144439</c:v>
                </c:pt>
                <c:pt idx="2">
                  <c:v>16.579814777858811</c:v>
                </c:pt>
                <c:pt idx="3">
                  <c:v>1.799796878859998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8320384"/>
        <c:axId val="38494592"/>
      </c:barChart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'13wk PS Red data'!$B$3:$E$3</c:f>
              <c:numCache>
                <c:formatCode>General</c:formatCode>
                <c:ptCount val="4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</c:numCache>
            </c:numRef>
          </c:xVal>
          <c:yVal>
            <c:numRef>
              <c:f>'13wk PS Red data'!$B$5:$E$5</c:f>
              <c:numCache>
                <c:formatCode>0.00</c:formatCode>
                <c:ptCount val="4"/>
                <c:pt idx="0">
                  <c:v>18.896315585140485</c:v>
                </c:pt>
                <c:pt idx="1">
                  <c:v>25.078782479542081</c:v>
                </c:pt>
                <c:pt idx="2">
                  <c:v>15.189211854449146</c:v>
                </c:pt>
                <c:pt idx="3">
                  <c:v>1.5919385423208832</c:v>
                </c:pt>
              </c:numCache>
            </c:numRef>
          </c:yVal>
          <c:smooth val="0"/>
        </c:ser>
        <c:ser>
          <c:idx val="1"/>
          <c:order val="1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('13wk PS Red data'!$B$2,'13wk PS Red data'!$C$3,'13wk PS Red data'!$D$3,'13wk PS Red data'!$E$3)</c:f>
              <c:numCache>
                <c:formatCode>General</c:formatCode>
                <c:ptCount val="4"/>
                <c:pt idx="0">
                  <c:v>0.96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</c:numCache>
            </c:numRef>
          </c:xVal>
          <c:yVal>
            <c:numRef>
              <c:f>'13wk PS Red data'!$B$6:$E$6</c:f>
              <c:numCache>
                <c:formatCode>0.00</c:formatCode>
                <c:ptCount val="4"/>
                <c:pt idx="0">
                  <c:v>17.782689673323272</c:v>
                </c:pt>
                <c:pt idx="1">
                  <c:v>20.638223335306183</c:v>
                </c:pt>
                <c:pt idx="2">
                  <c:v>21.114240776867188</c:v>
                </c:pt>
                <c:pt idx="3">
                  <c:v>0.13933607516543159</c:v>
                </c:pt>
              </c:numCache>
            </c:numRef>
          </c:yVal>
          <c:smooth val="0"/>
        </c:ser>
        <c:ser>
          <c:idx val="2"/>
          <c:order val="2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('13wk PS Red data'!$C$2,'13wk PS Red data'!$C$3,'13wk PS Red data'!$D$3,'13wk PS Red data'!$E$3)</c:f>
              <c:numCache>
                <c:formatCode>General</c:formatCode>
                <c:ptCount val="4"/>
                <c:pt idx="0">
                  <c:v>1.04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</c:numCache>
            </c:numRef>
          </c:xVal>
          <c:yVal>
            <c:numRef>
              <c:f>'13wk PS Red data'!$B$7:$E$7</c:f>
              <c:numCache>
                <c:formatCode>0.00</c:formatCode>
                <c:ptCount val="4"/>
                <c:pt idx="0">
                  <c:v>17.807328512480552</c:v>
                </c:pt>
                <c:pt idx="1">
                  <c:v>30.429306881585045</c:v>
                </c:pt>
                <c:pt idx="2">
                  <c:v>13.435991702260106</c:v>
                </c:pt>
                <c:pt idx="3">
                  <c:v>3.6681160190936812</c:v>
                </c:pt>
              </c:numCache>
            </c:numRef>
          </c:yVal>
          <c:smooth val="0"/>
        </c:ser>
        <c:ser>
          <c:idx val="3"/>
          <c:order val="3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'13wk PS Red data'!$B$3:$E$3</c:f>
              <c:numCache>
                <c:formatCode>General</c:formatCode>
                <c:ptCount val="4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</c:numCache>
            </c:numRef>
          </c:xVal>
          <c:yVal>
            <c:numRef>
              <c:f>'13wk PS Red data'!$B$8:$E$8</c:f>
              <c:numCache>
                <c:formatCode>General</c:formatCode>
                <c:ptCount val="4"/>
                <c:pt idx="0" formatCode="0.00">
                  <c:v>30.477943532216766</c:v>
                </c:pt>
              </c:numCache>
            </c:numRef>
          </c:yVal>
          <c:smooth val="0"/>
        </c:ser>
        <c:ser>
          <c:idx val="4"/>
          <c:order val="4"/>
          <c:spPr>
            <a:ln w="28575">
              <a:noFill/>
            </a:ln>
          </c:spPr>
          <c:xVal>
            <c:numRef>
              <c:f>'13wk PS Red data'!$B$3:$E$3</c:f>
              <c:numCache>
                <c:formatCode>General</c:formatCode>
                <c:ptCount val="4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</c:numCache>
            </c:numRef>
          </c:xVal>
          <c:yVal>
            <c:numRef>
              <c:f>'13wk PS Red data'!$B$9:$E$9</c:f>
              <c:numCache>
                <c:formatCode>General</c:formatCode>
                <c:ptCount val="4"/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8320384"/>
        <c:axId val="38494592"/>
      </c:scatterChart>
      <c:catAx>
        <c:axId val="3832038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crossAx val="38494592"/>
        <c:crosses val="autoZero"/>
        <c:auto val="1"/>
        <c:lblAlgn val="ctr"/>
        <c:lblOffset val="100"/>
        <c:noMultiLvlLbl val="0"/>
      </c:catAx>
      <c:valAx>
        <c:axId val="38494592"/>
        <c:scaling>
          <c:orientation val="minMax"/>
          <c:max val="4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dirty="0">
                    <a:latin typeface="Arial" panose="020B0604020202020204" pitchFamily="34" charset="0"/>
                    <a:cs typeface="Arial" panose="020B0604020202020204" pitchFamily="34" charset="0"/>
                  </a:rPr>
                  <a:t>PS Red Positive Area (%)</a:t>
                </a:r>
              </a:p>
            </c:rich>
          </c:tx>
          <c:layout>
            <c:manualLayout>
              <c:xMode val="edge"/>
              <c:yMode val="edge"/>
              <c:x val="0"/>
              <c:y val="0.21066163604549432"/>
            </c:manualLayout>
          </c:layout>
          <c:overlay val="0"/>
        </c:title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38320384"/>
        <c:crosses val="autoZero"/>
        <c:crossBetween val="between"/>
        <c:majorUnit val="10"/>
      </c:valAx>
      <c:spPr>
        <a:solidFill>
          <a:schemeClr val="bg1">
            <a:lumMod val="95000"/>
          </a:schemeClr>
        </a:solidFill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23518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350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86076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38661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63876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03241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17571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75853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32280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31966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41527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33354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6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0"/>
            <a:ext cx="8229600" cy="762000"/>
          </a:xfrm>
        </p:spPr>
        <p:txBody>
          <a:bodyPr>
            <a:noAutofit/>
          </a:bodyPr>
          <a:lstStyle/>
          <a:p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S3 Fig (Fig </a:t>
            </a:r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2A</a:t>
            </a:r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-13wk ORO Staining)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" name="Group 7"/>
          <p:cNvGrpSpPr/>
          <p:nvPr/>
        </p:nvGrpSpPr>
        <p:grpSpPr>
          <a:xfrm>
            <a:off x="4784436" y="990600"/>
            <a:ext cx="4359564" cy="2743200"/>
            <a:chOff x="4572000" y="2286000"/>
            <a:chExt cx="4359564" cy="2743200"/>
          </a:xfrm>
        </p:grpSpPr>
        <p:graphicFrame>
          <p:nvGraphicFramePr>
            <p:cNvPr id="4" name="Chart 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713438785"/>
                </p:ext>
              </p:extLst>
            </p:nvPr>
          </p:nvGraphicFramePr>
          <p:xfrm>
            <a:off x="4572000" y="2286000"/>
            <a:ext cx="4124739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5" name="TextBox 4"/>
            <p:cNvSpPr txBox="1"/>
            <p:nvPr/>
          </p:nvSpPr>
          <p:spPr>
            <a:xfrm>
              <a:off x="5045364" y="4697940"/>
              <a:ext cx="38862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 WD + SHS      WD Only    Chow + SHS   Chow Only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" name="Group 6"/>
          <p:cNvGrpSpPr/>
          <p:nvPr/>
        </p:nvGrpSpPr>
        <p:grpSpPr>
          <a:xfrm>
            <a:off x="441036" y="970254"/>
            <a:ext cx="4343400" cy="2743200"/>
            <a:chOff x="304800" y="2286000"/>
            <a:chExt cx="4343400" cy="2743200"/>
          </a:xfrm>
        </p:grpSpPr>
        <p:graphicFrame>
          <p:nvGraphicFramePr>
            <p:cNvPr id="3" name="Chart 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776053614"/>
                </p:ext>
              </p:extLst>
            </p:nvPr>
          </p:nvGraphicFramePr>
          <p:xfrm>
            <a:off x="304800" y="2286000"/>
            <a:ext cx="41148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6" name="TextBox 5"/>
            <p:cNvSpPr txBox="1"/>
            <p:nvPr/>
          </p:nvSpPr>
          <p:spPr>
            <a:xfrm>
              <a:off x="762000" y="4697940"/>
              <a:ext cx="38862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  WD + SHS      WD Only    Chow + SHS   Chow Only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9" name="TextBox 8"/>
          <p:cNvSpPr txBox="1"/>
          <p:nvPr/>
        </p:nvSpPr>
        <p:spPr>
          <a:xfrm>
            <a:off x="441036" y="826532"/>
            <a:ext cx="609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4782030" y="826532"/>
            <a:ext cx="609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12" name="Group 11"/>
          <p:cNvGrpSpPr/>
          <p:nvPr/>
        </p:nvGrpSpPr>
        <p:grpSpPr>
          <a:xfrm>
            <a:off x="2466687" y="3967490"/>
            <a:ext cx="4095173" cy="2852410"/>
            <a:chOff x="2448213" y="3886200"/>
            <a:chExt cx="4095173" cy="2852410"/>
          </a:xfrm>
        </p:grpSpPr>
        <p:grpSp>
          <p:nvGrpSpPr>
            <p:cNvPr id="13" name="Group 12"/>
            <p:cNvGrpSpPr/>
            <p:nvPr/>
          </p:nvGrpSpPr>
          <p:grpSpPr>
            <a:xfrm>
              <a:off x="2448213" y="3886200"/>
              <a:ext cx="4095173" cy="2852410"/>
              <a:chOff x="2448213" y="3733800"/>
              <a:chExt cx="4095173" cy="2852410"/>
            </a:xfrm>
          </p:grpSpPr>
          <p:graphicFrame>
            <p:nvGraphicFramePr>
              <p:cNvPr id="15" name="Chart 14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892138304"/>
                  </p:ext>
                </p:extLst>
              </p:nvPr>
            </p:nvGraphicFramePr>
            <p:xfrm>
              <a:off x="2448213" y="3733800"/>
              <a:ext cx="4095173" cy="27432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sp>
            <p:nvSpPr>
              <p:cNvPr id="16" name="TextBox 15"/>
              <p:cNvSpPr txBox="1"/>
              <p:nvPr/>
            </p:nvSpPr>
            <p:spPr>
              <a:xfrm>
                <a:off x="2590800" y="6324600"/>
                <a:ext cx="388620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      WD + SHS       WD Only     Chow + SHS     Chow Only</a:t>
                </a:r>
                <a:endParaRPr 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4" name="TextBox 13"/>
            <p:cNvSpPr txBox="1"/>
            <p:nvPr/>
          </p:nvSpPr>
          <p:spPr>
            <a:xfrm>
              <a:off x="2486602" y="3886200"/>
              <a:ext cx="6096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6958175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85</Words>
  <Application>Microsoft Office PowerPoint</Application>
  <PresentationFormat>On-screen Show (4:3)</PresentationFormat>
  <Paragraphs>1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3 Fig (Fig 2A -13wk ORO Staining)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1 Figure (Fig 1A -7wk ORO Staining)</dc:title>
  <dc:creator>Florence, Jon</dc:creator>
  <cp:lastModifiedBy>Florence, Jon</cp:lastModifiedBy>
  <cp:revision>5</cp:revision>
  <dcterms:created xsi:type="dcterms:W3CDTF">2017-01-26T23:47:11Z</dcterms:created>
  <dcterms:modified xsi:type="dcterms:W3CDTF">2017-01-26T23:57:56Z</dcterms:modified>
</cp:coreProperties>
</file>